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  <p:sldId id="270" r:id="rId3"/>
    <p:sldId id="260" r:id="rId4"/>
    <p:sldId id="256" r:id="rId5"/>
    <p:sldId id="257" r:id="rId6"/>
    <p:sldId id="258" r:id="rId7"/>
    <p:sldId id="259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505197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0576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8059860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76497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6007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900055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231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32182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45574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79767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27721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7F052-F024-481D-BEFE-A725EE291996}" type="datetimeFigureOut">
              <a:rPr lang="en-CA" smtClean="0"/>
              <a:t>2020-07-24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B26B49-08A9-490B-9EC6-9D13B3C8640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0017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47555"/>
              </p:ext>
            </p:extLst>
          </p:nvPr>
        </p:nvGraphicFramePr>
        <p:xfrm>
          <a:off x="4042759" y="1605814"/>
          <a:ext cx="4251235" cy="341376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567878"/>
                <a:gridCol w="1249250"/>
                <a:gridCol w="1171978"/>
                <a:gridCol w="1262129"/>
              </a:tblGrid>
              <a:tr h="41084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point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</a:tr>
              <a:tr h="41084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067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T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7 (32.1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.3 (25.3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4 (27.5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5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27178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EP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9.7 (39.0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1.7 (35.3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1.8 (37.0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8511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FP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5.7 </a:t>
                      </a: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.0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7.1 (35.3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9.6 (32.0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24003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FP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.5 (38.4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7 </a:t>
                      </a: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7.5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.6 </a:t>
                      </a: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0.4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</a:tr>
              <a:tr h="5207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P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 </a:t>
                      </a: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4.2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3 </a:t>
                      </a: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.5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2 </a:t>
                      </a: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3.1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3749906" y="5129991"/>
            <a:ext cx="4814546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3000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re mean (SD); KET = isometric knee extension torque, KEP = knee extension power, KFP = knee flexion power, PFP = plantar flexion power, DFP = dorsiflexion power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541693" y="824248"/>
            <a:ext cx="555079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1. Muscle torque (Nm) and muscle power (W) for time points 1 (week 0, n=18), 2 (week 9, n=17), and 3 (week 15, n=14) including all participants.</a:t>
            </a:r>
            <a:endParaRPr lang="en-US" altLang="en-US" sz="1400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35183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28034" y="4296615"/>
            <a:ext cx="11204620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8. Bland-Altman plot of agreement for the 4-meter fast pace walk (4MFP). The y-axis is the difference between the 2 time points (time point 3 – time point 1) and the x-axis is the average of the 2 time points [(time point 1 + time point 3)/2]. The middle line represents the bias estimate (-0.02 s) and the outer lines are the limits of agreement (-0.6 – 0.5 s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30921" y="156024"/>
            <a:ext cx="545288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22948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0760" y="4283736"/>
            <a:ext cx="11269014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9. Bland-Altman plot of agreement for the 400-meter walk (400MW). The y-axis is the difference between the 2 time points (time point 3 – time point 1) and the x-axis is the average of the 2 time points [(time point 1 + time point 3)/2]. The middle line represents the bias estimate (-10.9 s) and the outer lines are the limits of agreement (-53.4 – 31.7 s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8400" y="181782"/>
            <a:ext cx="5486411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065685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79549" y="4361009"/>
            <a:ext cx="11191741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0. Bland-Altman plot of agreement for the 5 chair stands (5CS). The y-axis is the difference between the 2 time points (time point 3 – time point 1) and the x-axis is the average of the 2 time points [(time point 1 + time point 3)/2]. The middle line represents the bias estimate (-1.3 s) and the outer lines are the limits of agreement (-4.8 – 2.1 s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4092" y="297691"/>
            <a:ext cx="5352299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4470190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02276" y="4283736"/>
            <a:ext cx="11114467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1. Bland-Altman plot of agreement for the 30-second chair stands (30sCS). The y-axis is the difference between the 2 time points (time point 3 – time point 1) and the x-axis is the average of the 2 time points [(time point 1 + time point 3)/2]. The middle line represents the bias estimate (1.6) and the outer lines are the limits of agreement (-2.8 – 6.0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84261" y="220418"/>
            <a:ext cx="534620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837453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99245" y="4309493"/>
            <a:ext cx="11269014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2. Bland-Altman plot of agreement for the stair climb usual pace (SCUP). The y-axis is the difference between the 2 time points (time point 3 – time point 1) and the x-axis is the average of the 2 time points [(time point 1 + time point 3)/2]. The middle line represents the bias estimate (-0.3 s) and the outer lines are the limits of agreement (-2.0 – 1.4 s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29715" y="156024"/>
            <a:ext cx="534620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9988187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56823" y="4386767"/>
            <a:ext cx="11281893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3. Bland-Altman plot of agreement for the stair climb fast pace (SCFP). The y-axis is the difference between the 2 time points (time point 3 – time point 1) and the x-axis is the average of the 2 time points [(time point 1 + time point 3)/2]. The middle line represents the bias estimate (-0.04 s) and the outer lines are the limits of agreement (-1.6 – 1.5 s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08195" y="246176"/>
            <a:ext cx="545288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42716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15155" y="4657223"/>
            <a:ext cx="11333409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4. Bland-Altman plot of agreement for stair climb power (SCP). The y-axis is the difference between the 2 time points (time point 3 – time point 1) and the x-axis is the average of the 2 time points [(time point 1 + time point 3)/2]. The middle line represents the bias estimate (-0.7 W) and the outer lines are the limits of agreement (-68.1 – 66.8 W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1919" y="284813"/>
            <a:ext cx="542240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02822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53838110"/>
              </p:ext>
            </p:extLst>
          </p:nvPr>
        </p:nvGraphicFramePr>
        <p:xfrm>
          <a:off x="553792" y="731106"/>
          <a:ext cx="6349284" cy="597408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1171977"/>
                <a:gridCol w="1751527"/>
                <a:gridCol w="1725769"/>
                <a:gridCol w="1700011"/>
              </a:tblGrid>
              <a:tr h="334718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ime point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</a:tr>
              <a:tr h="334718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68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PPB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9, 12)</a:t>
                      </a:r>
                      <a:r>
                        <a:rPr lang="en-US" sz="1400" kern="12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9, 12)</a:t>
                      </a:r>
                      <a:r>
                        <a:rPr lang="en-US" sz="1400" kern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 (9, 12)</a:t>
                      </a:r>
                      <a:r>
                        <a:rPr lang="en-US" sz="1400" kern="1200" baseline="300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</a:tr>
              <a:tr h="3068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MUP (s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5 (0.6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 (0.6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3 (0.5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3068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MFP (s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 (0.3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2 (0.4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 (0.3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3068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0MW(s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9.1 (31.4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3.0 (27.2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8.3 (16.0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3068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CS (s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3 (2.7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5 (1.7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1 (2.2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306825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sCS (reps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 (3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(3)</a:t>
                      </a:r>
                      <a:r>
                        <a:rPr lang="en-CA" sz="1400" kern="12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 (5)</a:t>
                      </a:r>
                      <a:r>
                        <a:rPr lang="en-CA" sz="1400" kern="1200" baseline="300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61365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UP (s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 (1.5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7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 (1.6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6 (1.2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61365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FP (s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1 (1.5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7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 (1.1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 (0.9)</a:t>
                      </a:r>
                      <a:endParaRPr lang="en-CA" sz="14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/>
                </a:tc>
              </a:tr>
              <a:tr h="613650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P (W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9.5 (180.1 - 475.7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7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1.1 (198.0 - 378.3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=17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CA" sz="1400" kern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6.5(166.6 - 413.5)</a:t>
                      </a:r>
                      <a:endParaRPr lang="en-CA" sz="14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2760" marR="62760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Rectangle 1"/>
          <p:cNvSpPr>
            <a:spLocks noChangeArrowheads="1"/>
          </p:cNvSpPr>
          <p:nvPr/>
        </p:nvSpPr>
        <p:spPr bwMode="auto">
          <a:xfrm>
            <a:off x="7232773" y="4419734"/>
            <a:ext cx="3662754" cy="22467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400" b="0" i="0" u="none" strike="noStrike" cap="none" normalizeH="0" baseline="3000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0" lang="en-US" altLang="en-US" sz="1400" b="0" i="0" u="none" strike="noStrike" cap="none" normalizeH="0" baseline="0" dirty="0" err="1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ata</a:t>
            </a:r>
            <a:r>
              <a:rPr kumimoji="0" lang="en-US" altLang="en-US" sz="1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re mean (SD), except for the SPPB and SCP, where medians (min, max) are displayed since data were not normally distributed; SPPB = Short Physical Performance Battery, 4MUP = 4-meter usual pace walk, 4MFP = 4-meter fast pace walk, 400MW = 400-meter walk, 5CS = 5 chair stands, 30sCS = 30-second chair stands, SCUP = stair climb usual pace, SCFP = stair climb fast pace, SCP = stair climb power for the SCFP</a:t>
            </a:r>
            <a:endParaRPr kumimoji="0" lang="en-US" altLang="en-US" sz="14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00926" y="153987"/>
            <a:ext cx="65021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ble S2. Functional performance for time points 1 (week 0, n=18), 2 (week 9, n=18), and 3 (week 15, n=16) including all participants.</a:t>
            </a:r>
            <a:endParaRPr lang="en-US" altLang="en-US" sz="1400" dirty="0"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846243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79549" y="4562764"/>
            <a:ext cx="11329114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Bland-Altman plot of agreement for knee extension torque (KET). The y-axis is the difference between the 2 time points (time point 3 – time point 1) and the x-axis is the average of the 2 time points [(time point 1 + time point 3)/2]. The middle line represents the bias estimate (-0.3 Nm) and the outer lines are the limits of agreement (-25.7 – 25.1 Nm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3604" y="207539"/>
            <a:ext cx="5416307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4776743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382074" y="4296616"/>
            <a:ext cx="11698310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Bland-Altman plot of agreement for knee extension power (KEP). The y-axis is the difference between the 2 time points (time point 3 – time point 1) and the x-axis is the average of the 2 time points [(time point 1 + time point 3)/2]. The middle line represents the bias estimate (5.4 W) and the outer lines are the limits of agreement (-24.0 – 34.8W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07525" y="143145"/>
            <a:ext cx="542240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9741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459346" y="4489796"/>
            <a:ext cx="11414975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. Bland-Altman plot of agreement for knee flexion power (KFP). The y-axis is the difference between the 2 time points (time point 3 – time point 1) and the x-axis is the average of the 2 time points [(time point 1 + time point 3)/2]. The middle line represents the bias estimate (6.3 W) and the outer lines are the limits of agreement (-30.8 – 43.4 W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4967" y="207539"/>
            <a:ext cx="5416307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6580817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360608" y="4373886"/>
            <a:ext cx="11449319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4. Bland-Altman plot of agreement for plantar flexion power (PFP). The y-axis is the difference between the 2 time points (time point 3 – time point 1) and the x-axis is the average of the 2 time points [(time point 1 + time point 3)/2]. The middle line represents the bias estimate (3.3 W) and the outer lines are the limits of agreement (-40.9 – 47.6 W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10573" y="271933"/>
            <a:ext cx="5416307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85599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95458" y="4386767"/>
            <a:ext cx="11191741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5. Bland-Altman plot of agreement for dorsiflexion power (DFP). The y-axis is the difference between the 2 time points (time point 3 – time point 1) and the x-axis is the average of the 2 time points [(time point 1 + time point 3)/2]. The middle line represents the bias estimate (-0.5 W) and the outer lines are the limits of agreement (-5.3 – 4.4 W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561" t="29484" r="17575" b="30328"/>
          <a:stretch/>
        </p:blipFill>
        <p:spPr>
          <a:xfrm>
            <a:off x="2846231" y="231817"/>
            <a:ext cx="5667669" cy="4211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421136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69702" y="4244894"/>
            <a:ext cx="11243256" cy="1991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6. Bland-Altman plot of agreement for the Short Physical Performance Battery (SPPB). The y-axis is the difference between the 2 time points (time point 3 – time point 1) and the x-axis is the average of the 2 time points [(time point 1 + time point 3)/2]. The middle line represents the bias estimate (0.4) and the outer lines are the limits of agreement (-0.8 – 1.6). Mean SPPB of 11.5: n= 3; Mean SPPB of 12: n=10; Other mean scores: n = 1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92284" y="271933"/>
            <a:ext cx="545288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51441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618185" y="4270857"/>
            <a:ext cx="11165983" cy="14993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CA" sz="1600" dirty="0" smtClean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7. Bland-Altman plot of agreement for the 4-meter usual pace walk (4MUP). The y-axis is the difference between the 2 time points (time point 3 – time point 1) and the x-axis is the average of the 2 time points [(time point 1 + time point 3)/2]. The middle line represents the bias estimate (-0.1 s) and the outer lines are the limits of agreement (-1.0 – 0.8 s).</a:t>
            </a:r>
            <a:endParaRPr lang="en-CA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7586" y="246175"/>
            <a:ext cx="5452883" cy="3995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42048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1604</Words>
  <Application>Microsoft Office PowerPoint</Application>
  <PresentationFormat>Widescreen</PresentationFormat>
  <Paragraphs>91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a Katsoulis</dc:creator>
  <cp:lastModifiedBy>Dina Katsoulis</cp:lastModifiedBy>
  <cp:revision>12</cp:revision>
  <dcterms:created xsi:type="dcterms:W3CDTF">2020-06-10T22:27:20Z</dcterms:created>
  <dcterms:modified xsi:type="dcterms:W3CDTF">2020-07-25T01:11:43Z</dcterms:modified>
</cp:coreProperties>
</file>